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483" autoAdjust="0"/>
    <p:restoredTop sz="89932"/>
  </p:normalViewPr>
  <p:slideViewPr>
    <p:cSldViewPr snapToGrid="0">
      <p:cViewPr varScale="1">
        <p:scale>
          <a:sx n="115" d="100"/>
          <a:sy n="115" d="100"/>
        </p:scale>
        <p:origin x="108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AF3C3E0-7FAB-B045-AE1A-B9E54295C894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6AE3EC4-0BDF-A842-B0D6-5ED2868BEE4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49484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6AE3EC4-0BDF-A842-B0D6-5ED2868BEE48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737305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D258EA-6D12-4FEF-A9B1-5EA713915C7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E1E1DAB-A63D-40F1-9658-BDB3D90065B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E02088-6FB4-4A6C-91F2-9C49922364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B1B70-A573-4970-A88D-0FABA075B92D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E9A786-5E04-4BED-A7D3-1888D479C4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15E2CF-EB16-4C74-A7BE-51FBCF1B3E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450E2-5FC2-47BD-901A-4D6A6F636C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10354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6ED4CA-AA88-4C65-8A50-0A66BCAE96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C6792D6-8316-4E66-BF54-D70EC57F51B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06328B-176D-4481-B6C1-B65F0B8557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B1B70-A573-4970-A88D-0FABA075B92D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B7240A-2289-40BE-BF9D-6210AE08BC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17E0E3-6087-4C05-8EFF-489A3C85F0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450E2-5FC2-47BD-901A-4D6A6F636C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47383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AB91476-F0A8-4E1C-9040-EAD454350B8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035C10B-6EAA-4B98-BEDF-C068FA1E79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955466-D6B0-4B9A-A3C8-C5E8196814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B1B70-A573-4970-A88D-0FABA075B92D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4E9E23-A7D9-4671-8587-D97B4B1175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83FF2F-1716-4B26-A23F-55092DF4CE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450E2-5FC2-47BD-901A-4D6A6F636C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19915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7ADF15-49BD-4F25-AE4A-CCDF07E287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58EB60D-12A1-4868-8F01-DA4F2BF2412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63CC5E-C4F8-4EB2-8AEA-8B0717B04F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B1B70-A573-4970-A88D-0FABA075B92D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B2B8A8-8612-477D-80AB-95622737B0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B18A618-2E01-4447-AA6E-05046446CD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450E2-5FC2-47BD-901A-4D6A6F636C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01975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6007DD-852E-4F5A-93BC-5C65A7583F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BC5CE93-C9C0-42EC-9030-9E221A85403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25ADAE-1FC7-4FAE-892B-7D6188E4B4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B1B70-A573-4970-A88D-0FABA075B92D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180910-C292-452F-A24A-369D4014C7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8744C3-BDD1-4243-881D-B004153E88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450E2-5FC2-47BD-901A-4D6A6F636C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90778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3C4C88-4BC2-4F5C-87BC-DA918811E4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2E3F58E-26B8-4D6C-8020-790E05ADD92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E05D7C1-6D1E-4689-936E-0F417E4FD72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A8EC32F-99D4-4FCC-973E-890566E2DF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B1B70-A573-4970-A88D-0FABA075B92D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73043A8-5985-4A66-B078-FB77E67E15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63D6B8B-6291-4D9C-817F-9F1CD707E3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450E2-5FC2-47BD-901A-4D6A6F636C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60635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79A4C2-ECE2-4757-BD56-19BDE2A3FF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0D7E5BC-B00B-40BE-A9E2-A8569737FA9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ECAFC74-C461-4552-A472-96F85F9DFB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88546C4-4A60-400A-8101-A163CB81DAB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3F13009-9C64-445D-B9C1-8A499C8E795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8D1FD5E-21D8-4A16-97E8-3EECF70304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B1B70-A573-4970-A88D-0FABA075B92D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93B7E6B-27BE-40EE-A877-4513848A9A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10BEF7E-7CDF-47A6-BE46-EE3C6CEE6D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450E2-5FC2-47BD-901A-4D6A6F636C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20707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F425F6-A9E7-4347-8F10-AFB909F5E3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2268BD3-B2AB-4066-9086-67F392BAD1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B1B70-A573-4970-A88D-0FABA075B92D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F239293-717F-47C9-85B3-7739C89A04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453851C-F8BC-456E-981C-0DAF2DE62E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450E2-5FC2-47BD-901A-4D6A6F636C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791587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FA14453-901E-4E33-A86D-C3F381DB94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B1B70-A573-4970-A88D-0FABA075B92D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7D9A248-F9EE-4628-A27F-0D5D4C42A5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B056412-3BA4-46C5-AD34-450C423E1D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450E2-5FC2-47BD-901A-4D6A6F636C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4379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A76AC8-BC18-4A3B-AFBC-EFEF65ACDF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D97D354-FC9A-4FB6-8F8C-B1D7FA9BDC2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B3CE681-A1CD-4DED-AEB5-F63CE943FDF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2143152-BF08-48D6-B801-7BA0E7FD32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B1B70-A573-4970-A88D-0FABA075B92D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A8BE96-0C89-4F68-913B-017120F568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293A18A-9AD6-4F26-B952-4CA87E538B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450E2-5FC2-47BD-901A-4D6A6F636C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44043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C34582-247E-4BD1-816F-BA5F84FF3E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0C9F5E5-F30A-4BA8-AEF3-E465E9215CD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8796752-A624-4302-8F45-08A768E26F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FCA1716-F83D-4B29-9F8E-5F18368F9E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BB1B70-A573-4970-A88D-0FABA075B92D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8652BB9-5D2D-44D2-B3EA-220E20687A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D169AEF-EFA0-433C-967D-26405A24C2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450E2-5FC2-47BD-901A-4D6A6F636C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40827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AA2F073-74E1-44E6-9BD9-9C795F204F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0D1286A-55A4-4577-AFFE-F1A131B8E2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8F63A2-967F-4606-84AC-6DB27083BBD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BB1B70-A573-4970-A88D-0FABA075B92D}" type="datetimeFigureOut">
              <a:rPr lang="en-GB" smtClean="0"/>
              <a:t>20/02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5BEF0A-05E7-4351-9413-24473D2ED2E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B2E33C-8E01-443D-A723-971F61916D2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B450E2-5FC2-47BD-901A-4D6A6F636C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26981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E7E8E27-C44F-4F90-95AB-8B35D894750B}"/>
              </a:ext>
            </a:extLst>
          </p:cNvPr>
          <p:cNvSpPr txBox="1"/>
          <p:nvPr/>
        </p:nvSpPr>
        <p:spPr>
          <a:xfrm>
            <a:off x="462656" y="6086590"/>
            <a:ext cx="1098605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ementary Figure 9: </a:t>
            </a:r>
            <a:r>
              <a:rPr lang="en-US" sz="1200" dirty="0"/>
              <a:t>Variation in lesion size between RILs containing alleles originating from PI251246 (PI) or Armenian </a:t>
            </a:r>
            <a:r>
              <a:rPr lang="en-US" sz="1200" i="1" dirty="0"/>
              <a:t>L. </a:t>
            </a:r>
            <a:r>
              <a:rPr lang="en-US" sz="1200" i="1" dirty="0" err="1"/>
              <a:t>serriola</a:t>
            </a:r>
            <a:r>
              <a:rPr lang="en-US" sz="1200" i="1" dirty="0"/>
              <a:t> </a:t>
            </a:r>
            <a:r>
              <a:rPr lang="en-US" sz="1200" dirty="0"/>
              <a:t>(Arm) at identified QTL markers. Violin plots show the distribution of least-squares predicted mean lesion size for RILs after inoculation with the pathogen relevant to the identified QTL (</a:t>
            </a:r>
            <a:r>
              <a:rPr lang="en-US" sz="1200" i="1" dirty="0"/>
              <a:t>B. cinerea </a:t>
            </a:r>
            <a:r>
              <a:rPr lang="en-US" sz="1200" dirty="0"/>
              <a:t>blue, </a:t>
            </a:r>
            <a:r>
              <a:rPr lang="en-US" sz="1200" i="1" dirty="0"/>
              <a:t>S. </a:t>
            </a:r>
            <a:r>
              <a:rPr lang="en-US" sz="1200" i="1" dirty="0" err="1"/>
              <a:t>sclerotiorum</a:t>
            </a:r>
            <a:r>
              <a:rPr lang="en-US" sz="1200" dirty="0"/>
              <a:t> red). Black horizontal bars represent the mean. Letters show statistical significance groupings (Tukey HSD p&lt;0.05) and the number of samples tested is indicated for each genotype. </a:t>
            </a:r>
            <a:endParaRPr lang="en-GB" sz="1200" dirty="0"/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2F89CA1-8BB2-4185-BB90-6CD8108F98D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85255" y="-5980"/>
            <a:ext cx="8721013" cy="61047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18081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6</TotalTime>
  <Words>97</Words>
  <Application>Microsoft Macintosh PowerPoint</Application>
  <PresentationFormat>Widescreen</PresentationFormat>
  <Paragraphs>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rry Pink</dc:creator>
  <cp:lastModifiedBy>Katherine Denby</cp:lastModifiedBy>
  <cp:revision>11</cp:revision>
  <dcterms:created xsi:type="dcterms:W3CDTF">2021-04-11T17:29:42Z</dcterms:created>
  <dcterms:modified xsi:type="dcterms:W3CDTF">2022-02-20T16:10:53Z</dcterms:modified>
</cp:coreProperties>
</file>